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F7A4E55-EFBF-4B15-B459-94C23110C08F}" v="2" dt="2026-03-11T19:51:10.41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celo Gottschalk" userId="61657d15-9e11-4569-9e56-f18948652ba6" providerId="ADAL" clId="{AA57C442-E63E-448A-84CD-BB86F3B20F26}"/>
    <pc:docChg chg="custSel modSld">
      <pc:chgData name="Marcelo Gottschalk" userId="61657d15-9e11-4569-9e56-f18948652ba6" providerId="ADAL" clId="{AA57C442-E63E-448A-84CD-BB86F3B20F26}" dt="2026-03-11T19:51:22.009" v="8" actId="114"/>
      <pc:docMkLst>
        <pc:docMk/>
      </pc:docMkLst>
      <pc:sldChg chg="addSp delSp modSp mod">
        <pc:chgData name="Marcelo Gottschalk" userId="61657d15-9e11-4569-9e56-f18948652ba6" providerId="ADAL" clId="{AA57C442-E63E-448A-84CD-BB86F3B20F26}" dt="2026-03-11T19:51:22.009" v="8" actId="114"/>
        <pc:sldMkLst>
          <pc:docMk/>
          <pc:sldMk cId="925002837" sldId="257"/>
        </pc:sldMkLst>
        <pc:spChg chg="mod">
          <ac:chgData name="Marcelo Gottschalk" userId="61657d15-9e11-4569-9e56-f18948652ba6" providerId="ADAL" clId="{AA57C442-E63E-448A-84CD-BB86F3B20F26}" dt="2026-03-11T19:51:22.009" v="8" actId="114"/>
          <ac:spMkLst>
            <pc:docMk/>
            <pc:sldMk cId="925002837" sldId="257"/>
            <ac:spMk id="3" creationId="{00000000-0000-0000-0000-000000000000}"/>
          </ac:spMkLst>
        </pc:spChg>
        <pc:spChg chg="add del">
          <ac:chgData name="Marcelo Gottschalk" userId="61657d15-9e11-4569-9e56-f18948652ba6" providerId="ADAL" clId="{AA57C442-E63E-448A-84CD-BB86F3B20F26}" dt="2026-03-11T19:51:00.653" v="1" actId="478"/>
          <ac:spMkLst>
            <pc:docMk/>
            <pc:sldMk cId="925002837" sldId="257"/>
            <ac:spMk id="5" creationId="{443875FE-0E47-60B7-75CC-2487CE78877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DED9534-5F93-419D-96D4-C8AE4F8575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D210075-D754-415B-ABD2-159B8A2F02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FE58CE8-3E44-4C9B-94AF-33C6F33B8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146E47-7660-47B5-A295-2B55452BC9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1DAF674-0517-43E5-B135-EB2264FE9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780506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2B0AF34-C187-493B-B2E5-461A379C02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914DEB3-86A3-45A9-A5A1-2C24813C91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CF9A3A-8C74-4545-911D-E3430326F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FAE34E9-57E6-4E79-8EC2-8776D5B8C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BB501D8-0755-4824-BEDC-ED0799F62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139591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2782A193-E711-4C1A-ABB9-08BAFC411F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18A0D65-9B2F-4391-BFC6-090284968B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A66F511-291D-4C7C-AD1E-E75DA3E7A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EEFEBA3-586F-4B95-BA30-F3FA61B40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262FF9-2B4F-464F-AB62-4ED8A01FF2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18933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523A1A-C5F6-4250-A5CE-BAAC1FCFB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0C9BD78-34A7-4C57-AC8B-1116EC1EB0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B81D68D-882F-4FDD-B954-F4BFEFA48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25EEE9E-CC9A-4E9E-AA9F-C9A03E2B9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35BAA1A-2021-4225-8B3E-319B4FEE9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17499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2674205-D27F-44A5-94E8-3237359B0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F03C547-6427-4CEC-9C2F-352311748E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2405684-E0EF-4CC1-80E0-0D15E94E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E0AB250-9772-4FA3-A26D-BE447BBE6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3D8B274-CC5E-498F-8778-4E91EAF47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33003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F2372A3-A631-40B5-88CD-6C4C28309D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1255DFA-9FF7-42C1-9AB9-116263A8BF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EFD962F-E9E3-44FC-B8F3-99AC3C2ECE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07C0E59-B5B9-47AC-A36C-937908A64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B565CAB-6995-42F3-B868-DFBC423CD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4757ED1-6C68-4684-A3F4-223E9593B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528226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88EBD83-669D-4656-88B2-A680D409CF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7E416FA-C058-4E83-AACA-9DAA9EB76A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1E99EB8-05E8-4908-BF78-9B1AB69D6E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B6EABF2-4140-4FF7-B5B4-352A57E2FC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8654B74-65D5-4FE0-94E7-09946B4613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F874105-9E02-43CB-9BFF-732BDB404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2B09C98-E1E3-40AD-A18D-70912D939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619717B-17BA-4BB5-AC66-6D5617980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260362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D0ACCED-28DA-41CF-B4C2-E9AB5B8D4A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5587A21-5C7A-42D8-9C08-FE6DDE018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6F851FD-AAC4-44B4-87C2-81382A032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A32CFA7-ABC2-4048-9249-F8E03CFD77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57752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1DDEACE-2267-42F1-B727-858F61DC0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6372AB86-8BC5-4459-9017-E3BE0BBF4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CFC3C782-8E8F-486A-9ED7-A101DF39F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282563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E50C2EF-6671-41E4-8060-6A5FED987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98C13CF-C5B2-4670-906C-F6B4C4D300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89D3FC6-D51E-4F21-8595-5ADF63275E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3BF5F21-9D08-411D-A22D-EA76E81B1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41C9DE2-76D6-48E3-9123-5E3148853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CD32BB2-C11B-46C7-8E4F-5371261E1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865466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80A0A90-386B-4A5C-B791-9EBD224A31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ED312D5-642F-423B-874C-B3324CE6A2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14E4B57-CECE-4163-BF05-3C312F2F6D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E9BC41F-7431-4106-BFBD-B5D4D3A76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810CAA-94AE-4B86-B387-B0198B1D9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369B49E-3356-49E1-824B-8D700BDF8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128606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23BA2E6-15B2-4D76-AB93-1D2AADF54E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93BBCA3-5B52-4BE6-8502-C555F4D7F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185322-67B3-4B90-BBC0-A9993D5222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49298F-C92C-4B16-9445-0C49C3C7F4F8}" type="datetimeFigureOut">
              <a:rPr lang="fr-CA" smtClean="0"/>
              <a:t>2026-03-11</a:t>
            </a:fld>
            <a:endParaRPr lang="fr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40CE5A1-E985-4149-BD1A-D0C47F5104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ADC5B56-CACE-48FA-9115-3EC44B5A0B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1C49B1-40C0-487D-A8A5-1E4E666DA769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423040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694685" y="4739053"/>
            <a:ext cx="1077429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/>
              <a:t>Additional Figure 1</a:t>
            </a:r>
            <a:r>
              <a:rPr lang="en-CA" dirty="0"/>
              <a:t>: </a:t>
            </a:r>
            <a:r>
              <a:rPr lang="en-US" b="1" dirty="0"/>
              <a:t>Effect of DON-contaminated feed on blood bacterial burden after </a:t>
            </a:r>
            <a:r>
              <a:rPr lang="en-US" b="1" i="1" dirty="0"/>
              <a:t>S. suis </a:t>
            </a:r>
            <a:r>
              <a:rPr lang="en-US" b="1" dirty="0"/>
              <a:t>infection</a:t>
            </a:r>
            <a:r>
              <a:rPr lang="en-US" dirty="0"/>
              <a:t>.</a:t>
            </a:r>
          </a:p>
          <a:p>
            <a:r>
              <a:rPr lang="en-CA" dirty="0"/>
              <a:t>Blood bacterial burden at 24 and 48 h post-infection of control pigs </a:t>
            </a:r>
            <a:r>
              <a:rPr lang="en-US" dirty="0"/>
              <a:t>and those fed during two </a:t>
            </a:r>
          </a:p>
          <a:p>
            <a:r>
              <a:rPr lang="en-US" dirty="0"/>
              <a:t>weeks with 1 ppm or 2 ppm of DON-contaminated diet after an intramuscularly experimental infection with 1 ml </a:t>
            </a:r>
          </a:p>
          <a:p>
            <a:r>
              <a:rPr lang="en-US" dirty="0"/>
              <a:t>containing 1 × 10</a:t>
            </a:r>
            <a:r>
              <a:rPr lang="en-US" baseline="30000" dirty="0"/>
              <a:t>8</a:t>
            </a:r>
            <a:r>
              <a:rPr lang="en-US" dirty="0"/>
              <a:t> CFU of a log-phase culture of </a:t>
            </a:r>
            <a:r>
              <a:rPr lang="en-US" i="1" dirty="0"/>
              <a:t>S. </a:t>
            </a:r>
            <a:r>
              <a:rPr lang="en-US" i="1" dirty="0" err="1"/>
              <a:t>suis</a:t>
            </a:r>
            <a:r>
              <a:rPr lang="en-US" i="1" dirty="0"/>
              <a:t> </a:t>
            </a:r>
            <a:r>
              <a:rPr lang="en-US" dirty="0"/>
              <a:t>serotype 2 strain P1/7.</a:t>
            </a:r>
            <a:endParaRPr lang="es-ES_tradnl" dirty="0"/>
          </a:p>
        </p:txBody>
      </p:sp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DA23640D-23D8-BDAA-0726-FFE275965A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7988268"/>
              </p:ext>
            </p:extLst>
          </p:nvPr>
        </p:nvGraphicFramePr>
        <p:xfrm>
          <a:off x="2852929" y="662178"/>
          <a:ext cx="5420010" cy="34529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719361" imgH="3006399" progId="Prism9.Document">
                  <p:embed/>
                </p:oleObj>
              </mc:Choice>
              <mc:Fallback>
                <p:oleObj name="Prism 9" r:id="rId2" imgW="4719361" imgH="3006399" progId="Prism9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DA23640D-23D8-BDAA-0726-FFE275965A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852929" y="662178"/>
                        <a:ext cx="5420010" cy="34529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2500283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e2b420a-8b2f-4b78-9415-de36cc156688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22A6DB3A6FD254FB6267B2146AFDF05" ma:contentTypeVersion="17" ma:contentTypeDescription="Crée un document." ma:contentTypeScope="" ma:versionID="576b2563439e23af2f2e3e24403edf3b">
  <xsd:schema xmlns:xsd="http://www.w3.org/2001/XMLSchema" xmlns:xs="http://www.w3.org/2001/XMLSchema" xmlns:p="http://schemas.microsoft.com/office/2006/metadata/properties" xmlns:ns3="4943895c-a54e-4b9d-b9bc-787108f71e91" xmlns:ns4="4e2b420a-8b2f-4b78-9415-de36cc156688" targetNamespace="http://schemas.microsoft.com/office/2006/metadata/properties" ma:root="true" ma:fieldsID="4e605cb820a31f85f278db78ada7efc3" ns3:_="" ns4:_="">
    <xsd:import namespace="4943895c-a54e-4b9d-b9bc-787108f71e91"/>
    <xsd:import namespace="4e2b420a-8b2f-4b78-9415-de36cc156688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LengthInSeconds" minOccurs="0"/>
                <xsd:element ref="ns4:MediaServiceDateTaken" minOccurs="0"/>
                <xsd:element ref="ns4:_activity" minOccurs="0"/>
                <xsd:element ref="ns4:MediaServiceObjectDetectorVersions" minOccurs="0"/>
                <xsd:element ref="ns4:MediaServiceSearchProperties" minOccurs="0"/>
                <xsd:element ref="ns4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943895c-a54e-4b9d-b9bc-787108f71e91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e2b420a-8b2f-4b78-9415-de36cc15668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8E026B7-CD06-4057-9F5E-99C3BF9161AC}">
  <ds:schemaRefs>
    <ds:schemaRef ds:uri="4e2b420a-8b2f-4b78-9415-de36cc156688"/>
    <ds:schemaRef ds:uri="4943895c-a54e-4b9d-b9bc-787108f71e91"/>
    <ds:schemaRef ds:uri="http://schemas.microsoft.com/office/2006/metadata/properties"/>
    <ds:schemaRef ds:uri="http://schemas.microsoft.com/office/2006/documentManagement/types"/>
    <ds:schemaRef ds:uri="http://purl.org/dc/terms/"/>
    <ds:schemaRef ds:uri="http://purl.org/dc/dcmitype/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F3853A66-4AA4-46F0-B7CA-AF123EEFA25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D43E824-2888-48BA-B582-09AB978BEA9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943895c-a54e-4b9d-b9bc-787108f71e91"/>
    <ds:schemaRef ds:uri="4e2b420a-8b2f-4b78-9415-de36cc15668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507</TotalTime>
  <Words>71</Words>
  <Application>Microsoft Office PowerPoint</Application>
  <PresentationFormat>Grand écran</PresentationFormat>
  <Paragraphs>4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9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nia Lacouture</dc:creator>
  <cp:lastModifiedBy>Marcelo Gottschalk</cp:lastModifiedBy>
  <cp:revision>6</cp:revision>
  <dcterms:created xsi:type="dcterms:W3CDTF">2025-08-26T20:01:47Z</dcterms:created>
  <dcterms:modified xsi:type="dcterms:W3CDTF">2026-03-11T19:51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22A6DB3A6FD254FB6267B2146AFDF05</vt:lpwstr>
  </property>
</Properties>
</file>